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6A44A-154F-4D69-83C7-85DF3D7C7F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94291-0061-4C11-8179-5A707FC6B0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EAE7A-2383-457E-ABA4-0E056F29A5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632B7-C59C-4354-AC11-F47808DE4E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C06BF-C886-431C-862C-45A367CB84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40005-8795-4DA0-985D-A666DC1860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D0C01-89DA-4947-98DE-0DFAFACA2A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A4988-B1A4-4D58-BDD6-FACFB7CF8C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6CA912-C03B-4E66-B079-53C1F0E63E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280C5-4A81-408B-BC72-1F7D579BE5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725FE-4F39-469E-8341-DDC5E76F0F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A8549-CA33-4797-9A4C-C5EF7ED48E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2F68B9-D53D-410E-861F-71FD0E2BA92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60" y="-44280"/>
            <a:ext cx="9144360" cy="5870880"/>
            <a:chOff x="360" y="-44280"/>
            <a:chExt cx="9144360" cy="5870880"/>
          </a:xfrm>
        </p:grpSpPr>
        <p:pic>
          <p:nvPicPr>
            <p:cNvPr id="42" name="Picture 11" descr="k=10"/>
            <p:cNvPicPr/>
            <p:nvPr/>
          </p:nvPicPr>
          <p:blipFill>
            <a:blip r:embed="rId1"/>
            <a:stretch/>
          </p:blipFill>
          <p:spPr>
            <a:xfrm>
              <a:off x="480240" y="3911040"/>
              <a:ext cx="8633160" cy="58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12" descr="k=11"/>
            <p:cNvPicPr/>
            <p:nvPr/>
          </p:nvPicPr>
          <p:blipFill>
            <a:blip r:embed="rId2"/>
            <a:stretch/>
          </p:blipFill>
          <p:spPr>
            <a:xfrm>
              <a:off x="474120" y="4411800"/>
              <a:ext cx="8639280" cy="606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Rectangle 14"/>
            <p:cNvSpPr/>
            <p:nvPr/>
          </p:nvSpPr>
          <p:spPr>
            <a:xfrm>
              <a:off x="344520" y="4941000"/>
              <a:ext cx="8719920" cy="187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62"/>
            <p:cNvSpPr/>
            <p:nvPr/>
          </p:nvSpPr>
          <p:spPr>
            <a:xfrm>
              <a:off x="8438400" y="4927320"/>
              <a:ext cx="341640" cy="700200"/>
            </a:xfrm>
            <a:prstGeom prst="rect">
              <a:avLst/>
            </a:prstGeom>
            <a:solidFill>
              <a:srgbClr val="dddddd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63"/>
            <p:cNvSpPr/>
            <p:nvPr/>
          </p:nvSpPr>
          <p:spPr>
            <a:xfrm>
              <a:off x="6709680" y="4933440"/>
              <a:ext cx="948600" cy="707760"/>
            </a:xfrm>
            <a:prstGeom prst="rect">
              <a:avLst/>
            </a:prstGeom>
            <a:solidFill>
              <a:srgbClr val="dddddd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64"/>
            <p:cNvSpPr/>
            <p:nvPr/>
          </p:nvSpPr>
          <p:spPr>
            <a:xfrm>
              <a:off x="570600" y="4933440"/>
              <a:ext cx="5455800" cy="710640"/>
            </a:xfrm>
            <a:prstGeom prst="rect">
              <a:avLst/>
            </a:prstGeom>
            <a:solidFill>
              <a:srgbClr val="dddddd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3" descr="k=2"/>
            <p:cNvPicPr/>
            <p:nvPr/>
          </p:nvPicPr>
          <p:blipFill>
            <a:blip r:embed="rId3"/>
            <a:stretch/>
          </p:blipFill>
          <p:spPr>
            <a:xfrm>
              <a:off x="461520" y="-44280"/>
              <a:ext cx="8652240" cy="527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4" descr="k=3"/>
            <p:cNvPicPr/>
            <p:nvPr/>
          </p:nvPicPr>
          <p:blipFill>
            <a:blip r:embed="rId4"/>
            <a:stretch/>
          </p:blipFill>
          <p:spPr>
            <a:xfrm>
              <a:off x="447480" y="454680"/>
              <a:ext cx="8666280" cy="512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5" descr="k=4"/>
            <p:cNvPicPr/>
            <p:nvPr/>
          </p:nvPicPr>
          <p:blipFill>
            <a:blip r:embed="rId5"/>
            <a:stretch/>
          </p:blipFill>
          <p:spPr>
            <a:xfrm>
              <a:off x="472320" y="921960"/>
              <a:ext cx="8641080" cy="55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6" descr="k=5"/>
            <p:cNvPicPr/>
            <p:nvPr/>
          </p:nvPicPr>
          <p:blipFill>
            <a:blip r:embed="rId6"/>
            <a:stretch/>
          </p:blipFill>
          <p:spPr>
            <a:xfrm>
              <a:off x="469440" y="1438920"/>
              <a:ext cx="8644320" cy="533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7" descr="k=6"/>
            <p:cNvPicPr/>
            <p:nvPr/>
          </p:nvPicPr>
          <p:blipFill>
            <a:blip r:embed="rId7"/>
            <a:stretch/>
          </p:blipFill>
          <p:spPr>
            <a:xfrm>
              <a:off x="483480" y="1942920"/>
              <a:ext cx="8629920" cy="52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8" descr="k=7"/>
            <p:cNvPicPr/>
            <p:nvPr/>
          </p:nvPicPr>
          <p:blipFill>
            <a:blip r:embed="rId8"/>
            <a:stretch/>
          </p:blipFill>
          <p:spPr>
            <a:xfrm>
              <a:off x="486720" y="2419560"/>
              <a:ext cx="8626680" cy="54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9" descr="k=8"/>
            <p:cNvPicPr/>
            <p:nvPr/>
          </p:nvPicPr>
          <p:blipFill>
            <a:blip r:embed="rId9"/>
            <a:stretch/>
          </p:blipFill>
          <p:spPr>
            <a:xfrm>
              <a:off x="486720" y="2936520"/>
              <a:ext cx="8626680" cy="52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10" descr="k=9"/>
            <p:cNvPicPr/>
            <p:nvPr/>
          </p:nvPicPr>
          <p:blipFill>
            <a:blip r:embed="rId10"/>
            <a:stretch/>
          </p:blipFill>
          <p:spPr>
            <a:xfrm>
              <a:off x="483480" y="3399480"/>
              <a:ext cx="8629920" cy="571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 Box 15"/>
            <p:cNvSpPr/>
            <p:nvPr/>
          </p:nvSpPr>
          <p:spPr>
            <a:xfrm>
              <a:off x="2711160" y="5474880"/>
              <a:ext cx="1363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Thames catchment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6"/>
            <p:cNvSpPr/>
            <p:nvPr/>
          </p:nvSpPr>
          <p:spPr>
            <a:xfrm>
              <a:off x="6115320" y="546444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e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7"/>
            <p:cNvSpPr/>
            <p:nvPr/>
          </p:nvSpPr>
          <p:spPr>
            <a:xfrm>
              <a:off x="8356320" y="543096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Tr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8"/>
            <p:cNvSpPr/>
            <p:nvPr/>
          </p:nvSpPr>
          <p:spPr>
            <a:xfrm>
              <a:off x="6926760" y="545508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Aru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9"/>
            <p:cNvSpPr/>
            <p:nvPr/>
          </p:nvSpPr>
          <p:spPr>
            <a:xfrm>
              <a:off x="7602480" y="5458320"/>
              <a:ext cx="817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GB" sz="900" spc="-1" strike="noStrike">
                  <a:solidFill>
                    <a:srgbClr val="000000"/>
                  </a:solidFill>
                  <a:latin typeface="Arial"/>
                </a:rPr>
                <a:t>Chelmer &amp;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Arial"/>
                </a:rPr>
                <a:t>Blackwat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20"/>
            <p:cNvSpPr/>
            <p:nvPr/>
          </p:nvSpPr>
          <p:spPr>
            <a:xfrm>
              <a:off x="5638680" y="5010840"/>
              <a:ext cx="122040" cy="51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amSha’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1"/>
            <p:cNvSpPr/>
            <p:nvPr/>
          </p:nvSpPr>
          <p:spPr>
            <a:xfrm>
              <a:off x="8718480" y="5430960"/>
              <a:ext cx="42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Ai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2"/>
            <p:cNvSpPr/>
            <p:nvPr/>
          </p:nvSpPr>
          <p:spPr>
            <a:xfrm>
              <a:off x="574560" y="4992840"/>
              <a:ext cx="122040" cy="51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eeHUS’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3"/>
            <p:cNvSpPr/>
            <p:nvPr/>
          </p:nvSpPr>
          <p:spPr>
            <a:xfrm>
              <a:off x="5461920" y="5004360"/>
              <a:ext cx="12204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RayRod’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4"/>
            <p:cNvSpPr/>
            <p:nvPr/>
          </p:nvSpPr>
          <p:spPr>
            <a:xfrm>
              <a:off x="5327280" y="5010840"/>
              <a:ext cx="122040" cy="51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BouChe’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5"/>
            <p:cNvSpPr/>
            <p:nvPr/>
          </p:nvSpPr>
          <p:spPr>
            <a:xfrm>
              <a:off x="5126400" y="5012640"/>
              <a:ext cx="122040" cy="51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BouChe’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6"/>
            <p:cNvSpPr/>
            <p:nvPr/>
          </p:nvSpPr>
          <p:spPr>
            <a:xfrm>
              <a:off x="4883040" y="5014080"/>
              <a:ext cx="122040" cy="51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BouChe’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7"/>
            <p:cNvSpPr/>
            <p:nvPr/>
          </p:nvSpPr>
          <p:spPr>
            <a:xfrm>
              <a:off x="4656600" y="5013720"/>
              <a:ext cx="122040" cy="524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MolMea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28"/>
            <p:cNvSpPr/>
            <p:nvPr/>
          </p:nvSpPr>
          <p:spPr>
            <a:xfrm>
              <a:off x="739440" y="4988880"/>
              <a:ext cx="122040" cy="494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eeHyd’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29"/>
            <p:cNvSpPr/>
            <p:nvPr/>
          </p:nvSpPr>
          <p:spPr>
            <a:xfrm>
              <a:off x="923040" y="4988880"/>
              <a:ext cx="122040" cy="494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eeHyd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0"/>
            <p:cNvSpPr/>
            <p:nvPr/>
          </p:nvSpPr>
          <p:spPr>
            <a:xfrm>
              <a:off x="1112760" y="4990680"/>
              <a:ext cx="122040" cy="30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ee’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1"/>
            <p:cNvSpPr/>
            <p:nvPr/>
          </p:nvSpPr>
          <p:spPr>
            <a:xfrm>
              <a:off x="1341720" y="4989600"/>
              <a:ext cx="122040" cy="45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eeEss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2"/>
            <p:cNvSpPr/>
            <p:nvPr/>
          </p:nvSpPr>
          <p:spPr>
            <a:xfrm>
              <a:off x="1623240" y="4989240"/>
              <a:ext cx="122040" cy="51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eeWhe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3"/>
            <p:cNvSpPr/>
            <p:nvPr/>
          </p:nvSpPr>
          <p:spPr>
            <a:xfrm>
              <a:off x="1816200" y="4993920"/>
              <a:ext cx="122040" cy="45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LeeSta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4"/>
            <p:cNvSpPr/>
            <p:nvPr/>
          </p:nvSpPr>
          <p:spPr>
            <a:xfrm>
              <a:off x="2013840" y="4993920"/>
              <a:ext cx="122040" cy="42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StoBri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5"/>
            <p:cNvSpPr/>
            <p:nvPr/>
          </p:nvSpPr>
          <p:spPr>
            <a:xfrm>
              <a:off x="2213280" y="5002200"/>
              <a:ext cx="122040" cy="46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StoTed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6"/>
            <p:cNvSpPr/>
            <p:nvPr/>
          </p:nvSpPr>
          <p:spPr>
            <a:xfrm>
              <a:off x="2444400" y="4998240"/>
              <a:ext cx="122040" cy="50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GadCas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7"/>
            <p:cNvSpPr/>
            <p:nvPr/>
          </p:nvSpPr>
          <p:spPr>
            <a:xfrm>
              <a:off x="2691000" y="4992840"/>
              <a:ext cx="122040" cy="50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KenNor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8"/>
            <p:cNvSpPr/>
            <p:nvPr/>
          </p:nvSpPr>
          <p:spPr>
            <a:xfrm>
              <a:off x="2878920" y="4999680"/>
              <a:ext cx="122040" cy="49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KenFou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9"/>
            <p:cNvSpPr/>
            <p:nvPr/>
          </p:nvSpPr>
          <p:spPr>
            <a:xfrm>
              <a:off x="5838120" y="5016600"/>
              <a:ext cx="122040" cy="56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WanMoh’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0"/>
            <p:cNvSpPr/>
            <p:nvPr/>
          </p:nvSpPr>
          <p:spPr>
            <a:xfrm>
              <a:off x="3073680" y="4998240"/>
              <a:ext cx="122040" cy="473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KenBul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1"/>
            <p:cNvSpPr/>
            <p:nvPr/>
          </p:nvSpPr>
          <p:spPr>
            <a:xfrm>
              <a:off x="3298320" y="5002200"/>
              <a:ext cx="122040" cy="470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BlaEvH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2"/>
            <p:cNvSpPr/>
            <p:nvPr/>
          </p:nvSpPr>
          <p:spPr>
            <a:xfrm>
              <a:off x="3506760" y="5005080"/>
              <a:ext cx="122040" cy="470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BlaEvH’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3"/>
            <p:cNvSpPr/>
            <p:nvPr/>
          </p:nvSpPr>
          <p:spPr>
            <a:xfrm>
              <a:off x="3734640" y="4995360"/>
              <a:ext cx="122040" cy="59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ThaSha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4"/>
            <p:cNvSpPr/>
            <p:nvPr/>
          </p:nvSpPr>
          <p:spPr>
            <a:xfrm>
              <a:off x="3954600" y="5009040"/>
              <a:ext cx="122040" cy="46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ThaCul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5"/>
            <p:cNvSpPr/>
            <p:nvPr/>
          </p:nvSpPr>
          <p:spPr>
            <a:xfrm>
              <a:off x="4170960" y="5004360"/>
              <a:ext cx="122040" cy="54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ThaHam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46"/>
            <p:cNvSpPr/>
            <p:nvPr/>
          </p:nvSpPr>
          <p:spPr>
            <a:xfrm>
              <a:off x="4422600" y="5016960"/>
              <a:ext cx="122040" cy="494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ThaWhi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7"/>
            <p:cNvSpPr/>
            <p:nvPr/>
          </p:nvSpPr>
          <p:spPr>
            <a:xfrm>
              <a:off x="6084720" y="5014800"/>
              <a:ext cx="122040" cy="474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NenEct’0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48"/>
            <p:cNvSpPr/>
            <p:nvPr/>
          </p:nvSpPr>
          <p:spPr>
            <a:xfrm>
              <a:off x="6535440" y="5004360"/>
              <a:ext cx="12204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NenEct’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9"/>
            <p:cNvSpPr/>
            <p:nvPr/>
          </p:nvSpPr>
          <p:spPr>
            <a:xfrm>
              <a:off x="6819840" y="5002200"/>
              <a:ext cx="122040" cy="48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AruHor’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50"/>
            <p:cNvSpPr/>
            <p:nvPr/>
          </p:nvSpPr>
          <p:spPr>
            <a:xfrm>
              <a:off x="7111080" y="5003640"/>
              <a:ext cx="122040" cy="48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AruHor’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1"/>
            <p:cNvSpPr/>
            <p:nvPr/>
          </p:nvSpPr>
          <p:spPr>
            <a:xfrm>
              <a:off x="7326360" y="5000040"/>
              <a:ext cx="122040" cy="617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AruHor’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2"/>
            <p:cNvSpPr/>
            <p:nvPr/>
          </p:nvSpPr>
          <p:spPr>
            <a:xfrm>
              <a:off x="7504920" y="5000040"/>
              <a:ext cx="122040" cy="64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AruHUS’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3"/>
            <p:cNvSpPr/>
            <p:nvPr/>
          </p:nvSpPr>
          <p:spPr>
            <a:xfrm>
              <a:off x="7748280" y="5008680"/>
              <a:ext cx="122040" cy="51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CheAbB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4"/>
            <p:cNvSpPr/>
            <p:nvPr/>
          </p:nvSpPr>
          <p:spPr>
            <a:xfrm>
              <a:off x="7993440" y="5000040"/>
              <a:ext cx="122040" cy="50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BlaBlm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5"/>
            <p:cNvSpPr/>
            <p:nvPr/>
          </p:nvSpPr>
          <p:spPr>
            <a:xfrm>
              <a:off x="8251200" y="5019120"/>
              <a:ext cx="122040" cy="404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BlaSti’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6"/>
            <p:cNvSpPr/>
            <p:nvPr/>
          </p:nvSpPr>
          <p:spPr>
            <a:xfrm>
              <a:off x="8436240" y="5022000"/>
              <a:ext cx="122040" cy="46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TreNot’0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7"/>
            <p:cNvSpPr/>
            <p:nvPr/>
          </p:nvSpPr>
          <p:spPr>
            <a:xfrm>
              <a:off x="8606880" y="5019120"/>
              <a:ext cx="122040" cy="474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TreWol’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58"/>
            <p:cNvSpPr/>
            <p:nvPr/>
          </p:nvSpPr>
          <p:spPr>
            <a:xfrm>
              <a:off x="8818920" y="5020560"/>
              <a:ext cx="122040" cy="44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AirDar’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59"/>
            <p:cNvSpPr/>
            <p:nvPr/>
          </p:nvSpPr>
          <p:spPr>
            <a:xfrm>
              <a:off x="6318720" y="4998600"/>
              <a:ext cx="122040" cy="50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Univers"/>
                </a:rPr>
                <a:t>NenBro’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86"/>
            <p:cNvSpPr/>
            <p:nvPr/>
          </p:nvSpPr>
          <p:spPr>
            <a:xfrm>
              <a:off x="333360" y="-20160"/>
              <a:ext cx="240480" cy="4973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76"/>
            <p:cNvSpPr/>
            <p:nvPr/>
          </p:nvSpPr>
          <p:spPr>
            <a:xfrm>
              <a:off x="2160" y="5220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77"/>
            <p:cNvSpPr/>
            <p:nvPr/>
          </p:nvSpPr>
          <p:spPr>
            <a:xfrm>
              <a:off x="3960" y="60732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78"/>
            <p:cNvSpPr/>
            <p:nvPr/>
          </p:nvSpPr>
          <p:spPr>
            <a:xfrm>
              <a:off x="3960" y="304092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79"/>
            <p:cNvSpPr/>
            <p:nvPr/>
          </p:nvSpPr>
          <p:spPr>
            <a:xfrm>
              <a:off x="3960" y="254376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80"/>
            <p:cNvSpPr/>
            <p:nvPr/>
          </p:nvSpPr>
          <p:spPr>
            <a:xfrm>
              <a:off x="2160" y="109296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81"/>
            <p:cNvSpPr/>
            <p:nvPr/>
          </p:nvSpPr>
          <p:spPr>
            <a:xfrm>
              <a:off x="5400" y="158760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82"/>
            <p:cNvSpPr/>
            <p:nvPr/>
          </p:nvSpPr>
          <p:spPr>
            <a:xfrm>
              <a:off x="5400" y="208512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83"/>
            <p:cNvSpPr/>
            <p:nvPr/>
          </p:nvSpPr>
          <p:spPr>
            <a:xfrm>
              <a:off x="360" y="4552200"/>
              <a:ext cx="61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1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84"/>
            <p:cNvSpPr/>
            <p:nvPr/>
          </p:nvSpPr>
          <p:spPr>
            <a:xfrm>
              <a:off x="5040" y="4056120"/>
              <a:ext cx="61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1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85"/>
            <p:cNvSpPr/>
            <p:nvPr/>
          </p:nvSpPr>
          <p:spPr>
            <a:xfrm>
              <a:off x="1080" y="3583800"/>
              <a:ext cx="51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K=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2" name=""/>
          <p:cNvSpPr/>
          <p:nvPr/>
        </p:nvSpPr>
        <p:spPr>
          <a:xfrm>
            <a:off x="0" y="5780160"/>
            <a:ext cx="914400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dditional file 6. 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Structure analyses plots using the </a:t>
            </a:r>
            <a:r>
              <a:rPr b="1" i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locprior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 model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 Each individual is represented by a thin horizontal line which is partitioned in to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K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 coloured segments representing an individual’s estimated membership to fractions of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K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 clusters.   The results of analyses of absolute values of Pr(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X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/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K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) and Delta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K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 generated in Structure Harvester [73] suggested the optimum number of genetic units to be 1 (indicating that all fish belong to a single population) using the standard admixture model and 3 using the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locprior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 model.  However, failure of this method to identify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structure may have resulted from the limited ability of the STRUCTURE model to perform well in situations when allele frequencies vary gradually across a geographic region as is the case in the roach populations from the Thames catchment, because most individuals will have mixed membership in multiple cluster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1T10:51:24Z</dcterms:created>
  <dc:creator>Patrick Hamilton</dc:creator>
  <dc:description/>
  <dc:language>en-US</dc:language>
  <cp:lastModifiedBy>Patrick Hamilton</cp:lastModifiedBy>
  <dcterms:modified xsi:type="dcterms:W3CDTF">2013-09-12T13:55:01Z</dcterms:modified>
  <cp:revision>5</cp:revision>
  <dc:subject/>
  <dc:title>Slide 1</dc:title>
</cp:coreProperties>
</file>